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0A4247-7365-4344-8388-A3997C8C074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F693F6-67E3-4B0F-AC5B-62698A3C19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7988B9-69EC-4F36-9EB8-6B4206DB521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3791C5-F433-40A0-8EFF-38B2B0D88F9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39E6D0-4D50-4EC8-A5CA-F19D52A4A1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5EA701-71FE-402B-ADBE-BB9BAC483D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54CD7E-DB4D-477E-AEAB-1E684B3E9A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38F24E-E50C-4AB7-ADCF-53678BCB72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D94766-CF1C-4EAC-B98E-799C6A5AC6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B35FC5-9DA8-4F86-9B4C-ACB6218D80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E9755E-50C5-4157-AB8A-C958C3AC5B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4A65A8-6CB9-4B07-ACAA-618F84A220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C63A285-6758-41EE-9497-3D05D563C74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3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字方塊 36"/>
          <p:cNvSpPr/>
          <p:nvPr/>
        </p:nvSpPr>
        <p:spPr>
          <a:xfrm>
            <a:off x="214200" y="380880"/>
            <a:ext cx="66438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Additional Figure 6. Changes in the correlation between codon usage in PB2 and that in human tissue-specific genes over time of viral isolation.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The linear regression line and the correlation coefficient of each dataset are shown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15"/>
          <p:cNvGrpSpPr/>
          <p:nvPr/>
        </p:nvGrpSpPr>
        <p:grpSpPr>
          <a:xfrm>
            <a:off x="270360" y="1325520"/>
            <a:ext cx="6397200" cy="7380360"/>
            <a:chOff x="270360" y="1325520"/>
            <a:chExt cx="6397200" cy="7380360"/>
          </a:xfrm>
        </p:grpSpPr>
        <p:grpSp>
          <p:nvGrpSpPr>
            <p:cNvPr id="43" name="Group 33"/>
            <p:cNvGrpSpPr/>
            <p:nvPr/>
          </p:nvGrpSpPr>
          <p:grpSpPr>
            <a:xfrm>
              <a:off x="1066680" y="1325520"/>
              <a:ext cx="5600880" cy="7223400"/>
              <a:chOff x="1066680" y="1325520"/>
              <a:chExt cx="5600880" cy="7223400"/>
            </a:xfrm>
          </p:grpSpPr>
          <p:grpSp>
            <p:nvGrpSpPr>
              <p:cNvPr id="44" name="Group 17"/>
              <p:cNvGrpSpPr/>
              <p:nvPr/>
            </p:nvGrpSpPr>
            <p:grpSpPr>
              <a:xfrm>
                <a:off x="1090440" y="1325520"/>
                <a:ext cx="5577120" cy="7223400"/>
                <a:chOff x="1090440" y="1325520"/>
                <a:chExt cx="5577120" cy="7223400"/>
              </a:xfrm>
            </p:grpSpPr>
            <p:sp>
              <p:nvSpPr>
                <p:cNvPr id="45" name="文字方塊 25"/>
                <p:cNvSpPr/>
                <p:nvPr/>
              </p:nvSpPr>
              <p:spPr>
                <a:xfrm>
                  <a:off x="1366920" y="1334160"/>
                  <a:ext cx="16048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(i) Human H1N1 virus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6" name="文字方塊 27"/>
                <p:cNvSpPr/>
                <p:nvPr/>
              </p:nvSpPr>
              <p:spPr>
                <a:xfrm>
                  <a:off x="5087160" y="1325520"/>
                  <a:ext cx="10904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(iii) Avian virus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47" name="群組 11"/>
                <p:cNvGrpSpPr/>
                <p:nvPr/>
              </p:nvGrpSpPr>
              <p:grpSpPr>
                <a:xfrm>
                  <a:off x="1206720" y="1700640"/>
                  <a:ext cx="1817640" cy="6848280"/>
                  <a:chOff x="1206720" y="1700640"/>
                  <a:chExt cx="1817640" cy="6848280"/>
                </a:xfrm>
              </p:grpSpPr>
              <p:pic>
                <p:nvPicPr>
                  <p:cNvPr id="48" name="Picture 2" descr=""/>
                  <p:cNvPicPr/>
                  <p:nvPr/>
                </p:nvPicPr>
                <p:blipFill>
                  <a:blip r:embed="rId1"/>
                  <a:srcRect l="0" t="0" r="51866" b="0"/>
                  <a:stretch/>
                </p:blipFill>
                <p:spPr>
                  <a:xfrm>
                    <a:off x="1206720" y="1700640"/>
                    <a:ext cx="1759320" cy="341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49" name="Picture 2" descr=""/>
                  <p:cNvPicPr/>
                  <p:nvPr/>
                </p:nvPicPr>
                <p:blipFill>
                  <a:blip r:embed="rId2"/>
                  <a:srcRect l="49880" t="0" r="0" b="0"/>
                  <a:stretch/>
                </p:blipFill>
                <p:spPr>
                  <a:xfrm>
                    <a:off x="1206720" y="5129280"/>
                    <a:ext cx="1817640" cy="341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grpSp>
            <p:grpSp>
              <p:nvGrpSpPr>
                <p:cNvPr id="50" name="群組 13"/>
                <p:cNvGrpSpPr/>
                <p:nvPr/>
              </p:nvGrpSpPr>
              <p:grpSpPr>
                <a:xfrm>
                  <a:off x="4849920" y="1691280"/>
                  <a:ext cx="1817640" cy="6857640"/>
                  <a:chOff x="4849920" y="1691280"/>
                  <a:chExt cx="1817640" cy="6857640"/>
                </a:xfrm>
              </p:grpSpPr>
              <p:pic>
                <p:nvPicPr>
                  <p:cNvPr id="51" name="Picture 2" descr=""/>
                  <p:cNvPicPr/>
                  <p:nvPr/>
                </p:nvPicPr>
                <p:blipFill>
                  <a:blip r:embed="rId3"/>
                  <a:srcRect l="0" t="0" r="50907" b="0"/>
                  <a:stretch/>
                </p:blipFill>
                <p:spPr>
                  <a:xfrm>
                    <a:off x="4908240" y="1691280"/>
                    <a:ext cx="1759320" cy="341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52" name="Picture 2" descr=""/>
                  <p:cNvPicPr/>
                  <p:nvPr/>
                </p:nvPicPr>
                <p:blipFill>
                  <a:blip r:embed="rId4"/>
                  <a:srcRect l="48979" t="0" r="0" b="273"/>
                  <a:stretch/>
                </p:blipFill>
                <p:spPr>
                  <a:xfrm>
                    <a:off x="4849920" y="5129280"/>
                    <a:ext cx="1817640" cy="341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grpSp>
            <p:sp>
              <p:nvSpPr>
                <p:cNvPr id="53" name="文字方塊 25"/>
                <p:cNvSpPr/>
                <p:nvPr/>
              </p:nvSpPr>
              <p:spPr>
                <a:xfrm>
                  <a:off x="3126600" y="1342080"/>
                  <a:ext cx="15447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(ii) Human H3N2 virus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54" name="群組 12"/>
                <p:cNvGrpSpPr/>
                <p:nvPr/>
              </p:nvGrpSpPr>
              <p:grpSpPr>
                <a:xfrm>
                  <a:off x="2999880" y="1691280"/>
                  <a:ext cx="1864440" cy="6857640"/>
                  <a:chOff x="2999880" y="1691280"/>
                  <a:chExt cx="1864440" cy="6857640"/>
                </a:xfrm>
              </p:grpSpPr>
              <p:pic>
                <p:nvPicPr>
                  <p:cNvPr id="55" name="Picture 2" descr=""/>
                  <p:cNvPicPr/>
                  <p:nvPr/>
                </p:nvPicPr>
                <p:blipFill>
                  <a:blip r:embed="rId5"/>
                  <a:srcRect l="0" t="0" r="51810" b="0"/>
                  <a:stretch/>
                </p:blipFill>
                <p:spPr>
                  <a:xfrm>
                    <a:off x="3036240" y="1691280"/>
                    <a:ext cx="1761120" cy="341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56" name="Picture 2" descr=""/>
                  <p:cNvPicPr/>
                  <p:nvPr/>
                </p:nvPicPr>
                <p:blipFill>
                  <a:blip r:embed="rId6"/>
                  <a:srcRect l="48979" t="0" r="0" b="0"/>
                  <a:stretch/>
                </p:blipFill>
                <p:spPr>
                  <a:xfrm>
                    <a:off x="2999880" y="5129280"/>
                    <a:ext cx="1864440" cy="341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grpSp>
            <p:sp>
              <p:nvSpPr>
                <p:cNvPr id="57" name="Rectangle 47"/>
                <p:cNvSpPr/>
                <p:nvPr/>
              </p:nvSpPr>
              <p:spPr>
                <a:xfrm>
                  <a:off x="1090440" y="1761840"/>
                  <a:ext cx="176040" cy="6644160"/>
                </a:xfrm>
                <a:prstGeom prst="rect">
                  <a:avLst/>
                </a:prstGeom>
                <a:solidFill>
                  <a:srgbClr val="ffffff"/>
                </a:solidFill>
                <a:ln w="255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8" name="Rectangle 48"/>
                <p:cNvSpPr/>
                <p:nvPr/>
              </p:nvSpPr>
              <p:spPr>
                <a:xfrm>
                  <a:off x="2966760" y="1904760"/>
                  <a:ext cx="117360" cy="6644160"/>
                </a:xfrm>
                <a:prstGeom prst="rect">
                  <a:avLst/>
                </a:prstGeom>
                <a:solidFill>
                  <a:srgbClr val="ffffff"/>
                </a:solidFill>
                <a:ln w="255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" name="Rectangle 49"/>
                <p:cNvSpPr/>
                <p:nvPr/>
              </p:nvSpPr>
              <p:spPr>
                <a:xfrm>
                  <a:off x="4842000" y="1690560"/>
                  <a:ext cx="117360" cy="6644160"/>
                </a:xfrm>
                <a:prstGeom prst="rect">
                  <a:avLst/>
                </a:prstGeom>
                <a:solidFill>
                  <a:srgbClr val="ffffff"/>
                </a:solidFill>
                <a:ln w="255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60" name="TextBox 143"/>
              <p:cNvSpPr/>
              <p:nvPr/>
            </p:nvSpPr>
            <p:spPr>
              <a:xfrm rot="16200000">
                <a:off x="651240" y="2418480"/>
                <a:ext cx="1098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Calibri"/>
                    <a:ea typeface="新細明體"/>
                  </a:rPr>
                  <a:t>Correlation coefficient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" name="TextBox 143"/>
              <p:cNvSpPr/>
              <p:nvPr/>
            </p:nvSpPr>
            <p:spPr>
              <a:xfrm rot="16200000">
                <a:off x="651240" y="4123440"/>
                <a:ext cx="1098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Calibri"/>
                    <a:ea typeface="新細明體"/>
                  </a:rPr>
                  <a:t>Correlation coefficient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TextBox 143"/>
              <p:cNvSpPr/>
              <p:nvPr/>
            </p:nvSpPr>
            <p:spPr>
              <a:xfrm rot="16200000">
                <a:off x="633960" y="5809320"/>
                <a:ext cx="1098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Calibri"/>
                    <a:ea typeface="新細明體"/>
                  </a:rPr>
                  <a:t>Correlation coefficient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TextBox 143"/>
              <p:cNvSpPr/>
              <p:nvPr/>
            </p:nvSpPr>
            <p:spPr>
              <a:xfrm rot="16200000">
                <a:off x="625320" y="7542720"/>
                <a:ext cx="1098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Calibri"/>
                    <a:ea typeface="新細明體"/>
                  </a:rPr>
                  <a:t>Correlation coefficient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" name="TextBox 143"/>
              <p:cNvSpPr/>
              <p:nvPr/>
            </p:nvSpPr>
            <p:spPr>
              <a:xfrm rot="16200000">
                <a:off x="2516400" y="2446920"/>
                <a:ext cx="1098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Calibri"/>
                    <a:ea typeface="新細明體"/>
                  </a:rPr>
                  <a:t>Correlation coefficient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TextBox 143"/>
              <p:cNvSpPr/>
              <p:nvPr/>
            </p:nvSpPr>
            <p:spPr>
              <a:xfrm rot="16200000">
                <a:off x="2506680" y="4151880"/>
                <a:ext cx="1098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Calibri"/>
                    <a:ea typeface="新細明體"/>
                  </a:rPr>
                  <a:t>Correlation coefficient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" name="TextBox 143"/>
              <p:cNvSpPr/>
              <p:nvPr/>
            </p:nvSpPr>
            <p:spPr>
              <a:xfrm rot="16200000">
                <a:off x="2489400" y="5837760"/>
                <a:ext cx="1098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Calibri"/>
                    <a:ea typeface="新細明體"/>
                  </a:rPr>
                  <a:t>Correlation coefficient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" name="TextBox 143"/>
              <p:cNvSpPr/>
              <p:nvPr/>
            </p:nvSpPr>
            <p:spPr>
              <a:xfrm rot="16200000">
                <a:off x="2490480" y="7571520"/>
                <a:ext cx="1098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Calibri"/>
                    <a:ea typeface="新細明體"/>
                  </a:rPr>
                  <a:t>Correlation coefficient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TextBox 143"/>
              <p:cNvSpPr/>
              <p:nvPr/>
            </p:nvSpPr>
            <p:spPr>
              <a:xfrm rot="16200000">
                <a:off x="4367880" y="2427840"/>
                <a:ext cx="1098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Calibri"/>
                    <a:ea typeface="新細明體"/>
                  </a:rPr>
                  <a:t>Correlation coefficient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TextBox 143"/>
              <p:cNvSpPr/>
              <p:nvPr/>
            </p:nvSpPr>
            <p:spPr>
              <a:xfrm rot="16200000">
                <a:off x="4362480" y="4122000"/>
                <a:ext cx="1098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Calibri"/>
                    <a:ea typeface="新細明體"/>
                  </a:rPr>
                  <a:t>Correlation coefficient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" name="TextBox 143"/>
              <p:cNvSpPr/>
              <p:nvPr/>
            </p:nvSpPr>
            <p:spPr>
              <a:xfrm rot="16200000">
                <a:off x="4356360" y="5818680"/>
                <a:ext cx="1098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Calibri"/>
                    <a:ea typeface="新細明體"/>
                  </a:rPr>
                  <a:t>Correlation coefficient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TextBox 143"/>
              <p:cNvSpPr/>
              <p:nvPr/>
            </p:nvSpPr>
            <p:spPr>
              <a:xfrm rot="16200000">
                <a:off x="4364280" y="7552440"/>
                <a:ext cx="1098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Calibri"/>
                    <a:ea typeface="新細明體"/>
                  </a:rPr>
                  <a:t>Correlation coefficient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" name="Rectangle 39"/>
              <p:cNvSpPr/>
              <p:nvPr/>
            </p:nvSpPr>
            <p:spPr>
              <a:xfrm>
                <a:off x="1349280" y="3276720"/>
                <a:ext cx="5015160" cy="29520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" name="Rectangle 40"/>
              <p:cNvSpPr/>
              <p:nvPr/>
            </p:nvSpPr>
            <p:spPr>
              <a:xfrm>
                <a:off x="1428480" y="4962600"/>
                <a:ext cx="5013720" cy="10476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4" name="TextBox 17"/>
            <p:cNvSpPr/>
            <p:nvPr/>
          </p:nvSpPr>
          <p:spPr>
            <a:xfrm>
              <a:off x="505440" y="2296080"/>
              <a:ext cx="4856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新細明體"/>
                </a:rPr>
                <a:t>Feta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新細明體"/>
                </a:rPr>
                <a:t>Lung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18"/>
            <p:cNvSpPr/>
            <p:nvPr/>
          </p:nvSpPr>
          <p:spPr>
            <a:xfrm>
              <a:off x="270360" y="3781800"/>
              <a:ext cx="80100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新細明體"/>
                </a:rPr>
                <a:t>Human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新細明體"/>
                </a:rPr>
                <a:t>Bronchial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新細明體"/>
                </a:rPr>
                <a:t>Epithelial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新細明體"/>
                </a:rPr>
                <a:t>Cell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19"/>
            <p:cNvSpPr/>
            <p:nvPr/>
          </p:nvSpPr>
          <p:spPr>
            <a:xfrm>
              <a:off x="318240" y="5743800"/>
              <a:ext cx="6760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新細明體"/>
                </a:rPr>
                <a:t>Adul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新細明體"/>
                </a:rPr>
                <a:t>Trache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Box 20"/>
            <p:cNvSpPr/>
            <p:nvPr/>
          </p:nvSpPr>
          <p:spPr>
            <a:xfrm>
              <a:off x="431640" y="7391520"/>
              <a:ext cx="5511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新細明體"/>
                </a:rPr>
                <a:t>Adult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新細明體"/>
                </a:rPr>
                <a:t>Lung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Rectangle 10"/>
            <p:cNvSpPr/>
            <p:nvPr/>
          </p:nvSpPr>
          <p:spPr>
            <a:xfrm>
              <a:off x="1454040" y="1599840"/>
              <a:ext cx="5015160" cy="2952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Rectangle 11"/>
            <p:cNvSpPr/>
            <p:nvPr/>
          </p:nvSpPr>
          <p:spPr>
            <a:xfrm>
              <a:off x="1473120" y="5038560"/>
              <a:ext cx="5015160" cy="2952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Rectangle 12"/>
            <p:cNvSpPr/>
            <p:nvPr/>
          </p:nvSpPr>
          <p:spPr>
            <a:xfrm>
              <a:off x="1339560" y="8410680"/>
              <a:ext cx="5015160" cy="2952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Box 114"/>
            <p:cNvSpPr/>
            <p:nvPr/>
          </p:nvSpPr>
          <p:spPr>
            <a:xfrm>
              <a:off x="1728720" y="3251520"/>
              <a:ext cx="985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新細明體"/>
                </a:rPr>
                <a:t>Year of isolat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114"/>
            <p:cNvSpPr/>
            <p:nvPr/>
          </p:nvSpPr>
          <p:spPr>
            <a:xfrm>
              <a:off x="1776240" y="4956480"/>
              <a:ext cx="985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新細明體"/>
                </a:rPr>
                <a:t>Year of isolat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Rectangle 15"/>
            <p:cNvSpPr/>
            <p:nvPr/>
          </p:nvSpPr>
          <p:spPr>
            <a:xfrm>
              <a:off x="1501560" y="6715080"/>
              <a:ext cx="5015160" cy="2952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Box 114"/>
            <p:cNvSpPr/>
            <p:nvPr/>
          </p:nvSpPr>
          <p:spPr>
            <a:xfrm>
              <a:off x="1757160" y="6670800"/>
              <a:ext cx="985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新細明體"/>
                </a:rPr>
                <a:t>Year of isolat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TextBox 114"/>
            <p:cNvSpPr/>
            <p:nvPr/>
          </p:nvSpPr>
          <p:spPr>
            <a:xfrm>
              <a:off x="1766520" y="8394840"/>
              <a:ext cx="985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新細明體"/>
                </a:rPr>
                <a:t>Year of isolat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Box 114"/>
            <p:cNvSpPr/>
            <p:nvPr/>
          </p:nvSpPr>
          <p:spPr>
            <a:xfrm>
              <a:off x="3538440" y="3251520"/>
              <a:ext cx="985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新細明體"/>
                </a:rPr>
                <a:t>Year of isolat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TextBox 114"/>
            <p:cNvSpPr/>
            <p:nvPr/>
          </p:nvSpPr>
          <p:spPr>
            <a:xfrm>
              <a:off x="3585960" y="4956480"/>
              <a:ext cx="985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新細明體"/>
                </a:rPr>
                <a:t>Year of isolat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TextBox 114"/>
            <p:cNvSpPr/>
            <p:nvPr/>
          </p:nvSpPr>
          <p:spPr>
            <a:xfrm>
              <a:off x="3567240" y="6670800"/>
              <a:ext cx="985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新細明體"/>
                </a:rPr>
                <a:t>Year of isolat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Box 114"/>
            <p:cNvSpPr/>
            <p:nvPr/>
          </p:nvSpPr>
          <p:spPr>
            <a:xfrm>
              <a:off x="3576600" y="8394840"/>
              <a:ext cx="985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新細明體"/>
                </a:rPr>
                <a:t>Year of isolat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TextBox 114"/>
            <p:cNvSpPr/>
            <p:nvPr/>
          </p:nvSpPr>
          <p:spPr>
            <a:xfrm>
              <a:off x="5357880" y="3251520"/>
              <a:ext cx="985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新細明體"/>
                </a:rPr>
                <a:t>Year of isolat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TextBox 114"/>
            <p:cNvSpPr/>
            <p:nvPr/>
          </p:nvSpPr>
          <p:spPr>
            <a:xfrm>
              <a:off x="5405400" y="4956480"/>
              <a:ext cx="985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新細明體"/>
                </a:rPr>
                <a:t>Year of isolat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TextBox 114"/>
            <p:cNvSpPr/>
            <p:nvPr/>
          </p:nvSpPr>
          <p:spPr>
            <a:xfrm>
              <a:off x="5386680" y="6670800"/>
              <a:ext cx="985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新細明體"/>
                </a:rPr>
                <a:t>Year of isolat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TextBox 114"/>
            <p:cNvSpPr/>
            <p:nvPr/>
          </p:nvSpPr>
          <p:spPr>
            <a:xfrm>
              <a:off x="5396040" y="8394840"/>
              <a:ext cx="985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新細明體"/>
                </a:rPr>
                <a:t>Year of isolat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14T04:26:20Z</dcterms:created>
  <dc:creator>llmpoon</dc:creator>
  <dc:description/>
  <dc:language>en-US</dc:language>
  <cp:lastModifiedBy>llmpoon</cp:lastModifiedBy>
  <dcterms:modified xsi:type="dcterms:W3CDTF">2010-04-14T04:28:44Z</dcterms:modified>
  <cp:revision>1</cp:revision>
  <dc:subject/>
  <dc:title>Slide 1</dc:title>
</cp:coreProperties>
</file>